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0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98" autoAdjust="0"/>
    <p:restoredTop sz="94694" autoAdjust="0"/>
  </p:normalViewPr>
  <p:slideViewPr>
    <p:cSldViewPr snapToGrid="0">
      <p:cViewPr varScale="1">
        <p:scale>
          <a:sx n="77" d="100"/>
          <a:sy n="77" d="100"/>
        </p:scale>
        <p:origin x="270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722378675637019E-2"/>
          <c:y val="9.3269022388432932E-2"/>
          <c:w val="0.90262006722843857"/>
          <c:h val="0.7357713619130942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PD-L1'!$H$44</c:f>
              <c:strCache>
                <c:ptCount val="1"/>
                <c:pt idx="0">
                  <c:v>SP(+)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pct9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919-4E98-A1F7-AC20C1E1664E}"/>
              </c:ext>
            </c:extLst>
          </c:dPt>
          <c:dPt>
            <c:idx val="1"/>
            <c:invertIfNegative val="0"/>
            <c:bubble3D val="0"/>
            <c:spPr>
              <a:pattFill prst="pct9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919-4E98-A1F7-AC20C1E1664E}"/>
              </c:ext>
            </c:extLst>
          </c:dPt>
          <c:cat>
            <c:strRef>
              <c:f>'PD-L1'!$I$43:$J$43</c:f>
              <c:strCache>
                <c:ptCount val="2"/>
                <c:pt idx="0">
                  <c:v>pCR</c:v>
                </c:pt>
                <c:pt idx="1">
                  <c:v>non-pCR</c:v>
                </c:pt>
              </c:strCache>
            </c:strRef>
          </c:cat>
          <c:val>
            <c:numRef>
              <c:f>'PD-L1'!$I$44:$J$44</c:f>
              <c:numCache>
                <c:formatCode>General</c:formatCode>
                <c:ptCount val="2"/>
                <c:pt idx="0">
                  <c:v>7</c:v>
                </c:pt>
                <c:pt idx="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919-4E98-A1F7-AC20C1E1664E}"/>
            </c:ext>
          </c:extLst>
        </c:ser>
        <c:ser>
          <c:idx val="1"/>
          <c:order val="1"/>
          <c:tx>
            <c:strRef>
              <c:f>'PD-L1'!$H$45</c:f>
              <c:strCache>
                <c:ptCount val="1"/>
                <c:pt idx="0">
                  <c:v>SP(-)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pct5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F919-4E98-A1F7-AC20C1E1664E}"/>
              </c:ext>
            </c:extLst>
          </c:dPt>
          <c:dPt>
            <c:idx val="1"/>
            <c:invertIfNegative val="0"/>
            <c:bubble3D val="0"/>
            <c:spPr>
              <a:pattFill prst="pct5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F919-4E98-A1F7-AC20C1E1664E}"/>
              </c:ext>
            </c:extLst>
          </c:dPt>
          <c:cat>
            <c:strRef>
              <c:f>'PD-L1'!$I$43:$J$43</c:f>
              <c:strCache>
                <c:ptCount val="2"/>
                <c:pt idx="0">
                  <c:v>pCR</c:v>
                </c:pt>
                <c:pt idx="1">
                  <c:v>non-pCR</c:v>
                </c:pt>
              </c:strCache>
            </c:strRef>
          </c:cat>
          <c:val>
            <c:numRef>
              <c:f>'PD-L1'!$I$45:$J$45</c:f>
              <c:numCache>
                <c:formatCode>General</c:formatCode>
                <c:ptCount val="2"/>
                <c:pt idx="0">
                  <c:v>11</c:v>
                </c:pt>
                <c:pt idx="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919-4E98-A1F7-AC20C1E166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10971592"/>
        <c:axId val="710972904"/>
      </c:barChart>
      <c:catAx>
        <c:axId val="7109715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10972904"/>
        <c:crosses val="autoZero"/>
        <c:auto val="1"/>
        <c:lblAlgn val="ctr"/>
        <c:lblOffset val="100"/>
        <c:noMultiLvlLbl val="0"/>
      </c:catAx>
      <c:valAx>
        <c:axId val="7109729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1097159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SPARC!$J$20:$K$20</c:f>
                <c:numCache>
                  <c:formatCode>General</c:formatCode>
                  <c:ptCount val="2"/>
                  <c:pt idx="0">
                    <c:v>25.284508372447426</c:v>
                  </c:pt>
                  <c:pt idx="1">
                    <c:v>29.5613090994123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PARC!$J$19:$K$19</c:f>
              <c:numCache>
                <c:formatCode>0.0</c:formatCode>
                <c:ptCount val="2"/>
                <c:pt idx="0" formatCode="0.0_ ">
                  <c:v>-62.75</c:v>
                </c:pt>
                <c:pt idx="1">
                  <c:v>-67.4363636363636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A8-4785-AEF1-70F65F3540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7545352"/>
        <c:axId val="647544040"/>
      </c:barChart>
      <c:catAx>
        <c:axId val="6475453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47544040"/>
        <c:crosses val="autoZero"/>
        <c:auto val="1"/>
        <c:lblAlgn val="ctr"/>
        <c:lblOffset val="100"/>
        <c:noMultiLvlLbl val="0"/>
      </c:catAx>
      <c:valAx>
        <c:axId val="647544040"/>
        <c:scaling>
          <c:orientation val="minMax"/>
          <c:min val="-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4754535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47186261244572"/>
          <c:y val="0.1633378568632175"/>
          <c:w val="0.90849347321631024"/>
          <c:h val="0.8019850893603879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PD-L1'!$M$3</c:f>
              <c:strCache>
                <c:ptCount val="1"/>
                <c:pt idx="0">
                  <c:v>(+)</c:v>
                </c:pt>
              </c:strCache>
            </c:strRef>
          </c:tx>
          <c:spPr>
            <a:pattFill prst="pct9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PD-L1'!$N$2:$O$2</c:f>
              <c:strCache>
                <c:ptCount val="2"/>
                <c:pt idx="0">
                  <c:v>pCR</c:v>
                </c:pt>
                <c:pt idx="1">
                  <c:v>non-pCR</c:v>
                </c:pt>
              </c:strCache>
            </c:strRef>
          </c:cat>
          <c:val>
            <c:numRef>
              <c:f>'PD-L1'!$N$3:$O$3</c:f>
              <c:numCache>
                <c:formatCode>General</c:formatCode>
                <c:ptCount val="2"/>
                <c:pt idx="0">
                  <c:v>9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C16-497A-9571-6ADAFF3CCB1C}"/>
            </c:ext>
          </c:extLst>
        </c:ser>
        <c:ser>
          <c:idx val="1"/>
          <c:order val="1"/>
          <c:tx>
            <c:strRef>
              <c:f>'PD-L1'!$M$4</c:f>
              <c:strCache>
                <c:ptCount val="1"/>
                <c:pt idx="0">
                  <c:v>(-)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PD-L1'!$N$2:$O$2</c:f>
              <c:strCache>
                <c:ptCount val="2"/>
                <c:pt idx="0">
                  <c:v>pCR</c:v>
                </c:pt>
                <c:pt idx="1">
                  <c:v>non-pCR</c:v>
                </c:pt>
              </c:strCache>
            </c:strRef>
          </c:cat>
          <c:val>
            <c:numRef>
              <c:f>'PD-L1'!$N$4:$O$4</c:f>
              <c:numCache>
                <c:formatCode>General</c:formatCode>
                <c:ptCount val="2"/>
                <c:pt idx="0">
                  <c:v>9</c:v>
                </c:pt>
                <c:pt idx="1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C16-497A-9571-6ADAFF3CCB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35441016"/>
        <c:axId val="735437736"/>
      </c:barChart>
      <c:catAx>
        <c:axId val="7354410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35437736"/>
        <c:crosses val="autoZero"/>
        <c:auto val="1"/>
        <c:lblAlgn val="ctr"/>
        <c:lblOffset val="100"/>
        <c:noMultiLvlLbl val="0"/>
      </c:catAx>
      <c:valAx>
        <c:axId val="7354377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3544101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9478D0-A7A9-478E-AEF2-15C41F2A8F6F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5EEE91-E916-4B6A-B507-F90FD194AA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90256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71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8014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0793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687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671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0371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3850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15002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6218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9913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81838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48972F-0B3C-4A8C-B688-4DFDABCF14F4}" type="datetimeFigureOut">
              <a:rPr kumimoji="1" lang="ja-JP" altLang="en-US" smtClean="0"/>
              <a:t>2022/8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9E20D9-582E-4395-9668-FAFDB10BE3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7806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18CC63F-68FA-326D-C197-12562A4533B0}"/>
              </a:ext>
            </a:extLst>
          </p:cNvPr>
          <p:cNvSpPr txBox="1"/>
          <p:nvPr/>
        </p:nvSpPr>
        <p:spPr>
          <a:xfrm>
            <a:off x="361463" y="283584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2B743B9-92D9-9F7A-4998-E974FBA45AA0}"/>
              </a:ext>
            </a:extLst>
          </p:cNvPr>
          <p:cNvSpPr txBox="1"/>
          <p:nvPr/>
        </p:nvSpPr>
        <p:spPr>
          <a:xfrm>
            <a:off x="4116663" y="93228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8045AEB-4082-99EB-8A8E-60773CA80D4A}"/>
              </a:ext>
            </a:extLst>
          </p:cNvPr>
          <p:cNvSpPr txBox="1"/>
          <p:nvPr/>
        </p:nvSpPr>
        <p:spPr>
          <a:xfrm>
            <a:off x="1167492" y="932289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D3E11039-3BAC-E7D4-F717-C68467F0E26E}"/>
              </a:ext>
            </a:extLst>
          </p:cNvPr>
          <p:cNvGrpSpPr/>
          <p:nvPr/>
        </p:nvGrpSpPr>
        <p:grpSpPr>
          <a:xfrm>
            <a:off x="1007842" y="1555277"/>
            <a:ext cx="1941507" cy="2063024"/>
            <a:chOff x="1350860" y="4034164"/>
            <a:chExt cx="1941507" cy="2063024"/>
          </a:xfrm>
        </p:grpSpPr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A9714A7F-ED77-1A33-5398-0C64ECDEFB7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69994173"/>
                </p:ext>
              </p:extLst>
            </p:nvPr>
          </p:nvGraphicFramePr>
          <p:xfrm>
            <a:off x="1599245" y="4213817"/>
            <a:ext cx="1693122" cy="14510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C952E26E-0488-CB80-06F9-EE195C8C4453}"/>
                </a:ext>
              </a:extLst>
            </p:cNvPr>
            <p:cNvSpPr txBox="1"/>
            <p:nvPr/>
          </p:nvSpPr>
          <p:spPr>
            <a:xfrm>
              <a:off x="2028859" y="4611326"/>
              <a:ext cx="361882" cy="2502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F5E8635B-BC7F-86AF-4FF5-A0505CE4AD84}"/>
                </a:ext>
              </a:extLst>
            </p:cNvPr>
            <p:cNvSpPr txBox="1"/>
            <p:nvPr/>
          </p:nvSpPr>
          <p:spPr>
            <a:xfrm>
              <a:off x="2814262" y="4688373"/>
              <a:ext cx="161858" cy="2502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D53AFCD1-3952-2F8D-6A14-CB411594FE97}"/>
                </a:ext>
              </a:extLst>
            </p:cNvPr>
            <p:cNvSpPr txBox="1"/>
            <p:nvPr/>
          </p:nvSpPr>
          <p:spPr>
            <a:xfrm>
              <a:off x="2806830" y="5085094"/>
              <a:ext cx="160192" cy="2502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ja-JP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7B79ED39-27B2-0023-788A-D10EE8C7BF91}"/>
                </a:ext>
              </a:extLst>
            </p:cNvPr>
            <p:cNvSpPr txBox="1"/>
            <p:nvPr/>
          </p:nvSpPr>
          <p:spPr>
            <a:xfrm>
              <a:off x="1976692" y="5413644"/>
              <a:ext cx="397455" cy="1778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CR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11906ABA-64C6-FF3A-F512-7AAF88799FF0}"/>
                </a:ext>
              </a:extLst>
            </p:cNvPr>
            <p:cNvSpPr txBox="1"/>
            <p:nvPr/>
          </p:nvSpPr>
          <p:spPr>
            <a:xfrm>
              <a:off x="2599458" y="5414500"/>
              <a:ext cx="638888" cy="1778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</a:t>
              </a:r>
              <a:r>
                <a:rPr kumimoji="1" lang="en-US" altLang="ja-JP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CR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839E4A8B-6E48-C333-E61E-D8D839202F12}"/>
                </a:ext>
              </a:extLst>
            </p:cNvPr>
            <p:cNvSpPr txBox="1"/>
            <p:nvPr/>
          </p:nvSpPr>
          <p:spPr>
            <a:xfrm>
              <a:off x="1981020" y="5594102"/>
              <a:ext cx="609391" cy="20851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=18)</a:t>
              </a:r>
              <a:endPara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9B5C877A-DBEC-0DEA-1B22-3FE9DF30E824}"/>
                </a:ext>
              </a:extLst>
            </p:cNvPr>
            <p:cNvSpPr txBox="1"/>
            <p:nvPr/>
          </p:nvSpPr>
          <p:spPr>
            <a:xfrm>
              <a:off x="2700593" y="5594102"/>
              <a:ext cx="583918" cy="20851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=16)</a:t>
              </a:r>
              <a:endPara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567922C1-ACE5-0027-4130-5FA778108785}"/>
                </a:ext>
              </a:extLst>
            </p:cNvPr>
            <p:cNvGrpSpPr/>
            <p:nvPr/>
          </p:nvGrpSpPr>
          <p:grpSpPr>
            <a:xfrm>
              <a:off x="2031548" y="4229532"/>
              <a:ext cx="953548" cy="239773"/>
              <a:chOff x="4931228" y="2105100"/>
              <a:chExt cx="3178629" cy="1001482"/>
            </a:xfrm>
          </p:grpSpPr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id="{D95390C7-2B09-4B1E-63E7-0CC0D7E4C3AB}"/>
                  </a:ext>
                </a:extLst>
              </p:cNvPr>
              <p:cNvCxnSpPr/>
              <p:nvPr/>
            </p:nvCxnSpPr>
            <p:spPr>
              <a:xfrm>
                <a:off x="4943872" y="2111825"/>
                <a:ext cx="0" cy="39188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4E662D8E-7B50-F8DF-865E-C961B7A2A8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61645" y="2105100"/>
                <a:ext cx="0" cy="100148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線コネクタ 23">
                <a:extLst>
                  <a:ext uri="{FF2B5EF4-FFF2-40B4-BE49-F238E27FC236}">
                    <a16:creationId xmlns:a16="http://schemas.microsoft.com/office/drawing/2014/main" id="{F093A0B4-1633-4B21-2669-AA90623D61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31228" y="2122711"/>
                <a:ext cx="317862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6B062871-873B-42B2-5B8D-8FC21AA87E13}"/>
                </a:ext>
              </a:extLst>
            </p:cNvPr>
            <p:cNvSpPr txBox="1"/>
            <p:nvPr/>
          </p:nvSpPr>
          <p:spPr>
            <a:xfrm>
              <a:off x="2281043" y="4142317"/>
              <a:ext cx="564728" cy="2085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774</a:t>
              </a:r>
              <a:endPara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33352B75-2C1D-65C3-3A8B-8791F9311CA0}"/>
                </a:ext>
              </a:extLst>
            </p:cNvPr>
            <p:cNvSpPr/>
            <p:nvPr/>
          </p:nvSpPr>
          <p:spPr>
            <a:xfrm>
              <a:off x="2503123" y="5929964"/>
              <a:ext cx="104611" cy="106006"/>
            </a:xfrm>
            <a:prstGeom prst="rect">
              <a:avLst/>
            </a:prstGeom>
            <a:pattFill prst="pct9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FF2FA13D-5DFF-11FF-373D-A6AFFDE34E58}"/>
                </a:ext>
              </a:extLst>
            </p:cNvPr>
            <p:cNvSpPr/>
            <p:nvPr/>
          </p:nvSpPr>
          <p:spPr>
            <a:xfrm>
              <a:off x="2886548" y="5929964"/>
              <a:ext cx="104611" cy="106006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18308B3E-8B26-8698-A328-4CE905732156}"/>
                </a:ext>
              </a:extLst>
            </p:cNvPr>
            <p:cNvSpPr txBox="1"/>
            <p:nvPr/>
          </p:nvSpPr>
          <p:spPr>
            <a:xfrm>
              <a:off x="1911440" y="5866356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SPARC</a:t>
              </a:r>
              <a:endParaRPr kumimoji="1" lang="ja-JP" altLang="en-US" sz="9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482B8435-826B-D342-FCB3-7EFC81C5172B}"/>
                </a:ext>
              </a:extLst>
            </p:cNvPr>
            <p:cNvSpPr txBox="1"/>
            <p:nvPr/>
          </p:nvSpPr>
          <p:spPr>
            <a:xfrm>
              <a:off x="2586502" y="5866356"/>
              <a:ext cx="3273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B8DE3A98-7B8F-9A02-F3B4-8764725D6D71}"/>
                </a:ext>
              </a:extLst>
            </p:cNvPr>
            <p:cNvSpPr txBox="1"/>
            <p:nvPr/>
          </p:nvSpPr>
          <p:spPr>
            <a:xfrm>
              <a:off x="2961336" y="586635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4005AD23-AF2E-DC95-1B3A-5673D65307F8}"/>
                </a:ext>
              </a:extLst>
            </p:cNvPr>
            <p:cNvSpPr txBox="1"/>
            <p:nvPr/>
          </p:nvSpPr>
          <p:spPr>
            <a:xfrm>
              <a:off x="2056276" y="5082286"/>
              <a:ext cx="160192" cy="2502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ja-JP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2449BD90-ED70-BCE9-7CE7-6F4E0C9DD2A6}"/>
                </a:ext>
              </a:extLst>
            </p:cNvPr>
            <p:cNvSpPr txBox="1"/>
            <p:nvPr/>
          </p:nvSpPr>
          <p:spPr>
            <a:xfrm rot="16200000">
              <a:off x="592159" y="4792865"/>
              <a:ext cx="17636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SPARC expression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9C928F49-EAF4-2535-E216-718CE7FB0682}"/>
              </a:ext>
            </a:extLst>
          </p:cNvPr>
          <p:cNvGrpSpPr/>
          <p:nvPr/>
        </p:nvGrpSpPr>
        <p:grpSpPr>
          <a:xfrm>
            <a:off x="3249790" y="1438167"/>
            <a:ext cx="2914538" cy="2220411"/>
            <a:chOff x="2117864" y="1234623"/>
            <a:chExt cx="2914538" cy="2220411"/>
          </a:xfrm>
        </p:grpSpPr>
        <p:graphicFrame>
          <p:nvGraphicFramePr>
            <p:cNvPr id="45" name="グラフ 44">
              <a:extLst>
                <a:ext uri="{FF2B5EF4-FFF2-40B4-BE49-F238E27FC236}">
                  <a16:creationId xmlns:a16="http://schemas.microsoft.com/office/drawing/2014/main" id="{B0884C95-DC57-EC68-66BB-3B98F7B764E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94504308"/>
                </p:ext>
              </p:extLst>
            </p:nvPr>
          </p:nvGraphicFramePr>
          <p:xfrm>
            <a:off x="2338970" y="1542921"/>
            <a:ext cx="2693432" cy="18023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E4AE33F4-E3B0-73D9-D58E-9D3FC0B99CB6}"/>
                </a:ext>
              </a:extLst>
            </p:cNvPr>
            <p:cNvGrpSpPr/>
            <p:nvPr/>
          </p:nvGrpSpPr>
          <p:grpSpPr>
            <a:xfrm flipH="1" flipV="1">
              <a:off x="3261418" y="3057925"/>
              <a:ext cx="1206653" cy="273310"/>
              <a:chOff x="4931228" y="2108597"/>
              <a:chExt cx="3178629" cy="1001483"/>
            </a:xfrm>
          </p:grpSpPr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697DFAC2-92C5-434F-2869-2E8C906FC61A}"/>
                  </a:ext>
                </a:extLst>
              </p:cNvPr>
              <p:cNvCxnSpPr/>
              <p:nvPr/>
            </p:nvCxnSpPr>
            <p:spPr>
              <a:xfrm>
                <a:off x="4943872" y="2111825"/>
                <a:ext cx="0" cy="39188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線コネクタ 47">
                <a:extLst>
                  <a:ext uri="{FF2B5EF4-FFF2-40B4-BE49-F238E27FC236}">
                    <a16:creationId xmlns:a16="http://schemas.microsoft.com/office/drawing/2014/main" id="{A107538E-65D2-8321-39D4-9FEDF19A66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83146" y="2108597"/>
                <a:ext cx="0" cy="100148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38E2D107-09C2-34B6-B9D7-E185865CCE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31228" y="2122711"/>
                <a:ext cx="317862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D5DC0DA9-31D0-ABD4-8A19-0A8029DCA233}"/>
                </a:ext>
              </a:extLst>
            </p:cNvPr>
            <p:cNvSpPr txBox="1"/>
            <p:nvPr/>
          </p:nvSpPr>
          <p:spPr>
            <a:xfrm>
              <a:off x="3600322" y="3224202"/>
              <a:ext cx="564728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646</a:t>
              </a:r>
              <a:endPara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C1009E30-4C71-6C95-5EC4-D04C10483634}"/>
                </a:ext>
              </a:extLst>
            </p:cNvPr>
            <p:cNvSpPr txBox="1"/>
            <p:nvPr/>
          </p:nvSpPr>
          <p:spPr>
            <a:xfrm>
              <a:off x="3554551" y="1234623"/>
              <a:ext cx="6562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SPARC</a:t>
              </a:r>
              <a:endParaRPr kumimoji="1" lang="ja-JP" altLang="en-US" sz="12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9EDD76E3-6570-FE93-D3C1-1A06DC2546A0}"/>
                </a:ext>
              </a:extLst>
            </p:cNvPr>
            <p:cNvSpPr txBox="1"/>
            <p:nvPr/>
          </p:nvSpPr>
          <p:spPr>
            <a:xfrm>
              <a:off x="3164832" y="1402699"/>
              <a:ext cx="3738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3089BDB1-6973-8BE1-09DF-B5D3C5A47D4B}"/>
                </a:ext>
              </a:extLst>
            </p:cNvPr>
            <p:cNvSpPr txBox="1"/>
            <p:nvPr/>
          </p:nvSpPr>
          <p:spPr>
            <a:xfrm>
              <a:off x="4192967" y="1402699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81F83ECC-5462-969B-405A-E9F5CC5D5137}"/>
                </a:ext>
              </a:extLst>
            </p:cNvPr>
            <p:cNvSpPr txBox="1"/>
            <p:nvPr/>
          </p:nvSpPr>
          <p:spPr>
            <a:xfrm rot="16200000">
              <a:off x="1368192" y="2261293"/>
              <a:ext cx="183789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st percentage change</a:t>
              </a:r>
              <a:r>
                <a: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　</a:t>
              </a:r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 baseline</a:t>
              </a:r>
            </a:p>
            <a:p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after nab-PTX and HP treatment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2BBC1B4E-9D07-BF1E-EDF2-C327CE1CB007}"/>
                </a:ext>
              </a:extLst>
            </p:cNvPr>
            <p:cNvSpPr txBox="1"/>
            <p:nvPr/>
          </p:nvSpPr>
          <p:spPr>
            <a:xfrm>
              <a:off x="3134778" y="1959926"/>
              <a:ext cx="4539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2.8</a:t>
              </a:r>
              <a:endParaRPr kumimoji="1" lang="ja-JP" altLang="en-US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FCD73A09-E57D-DD7A-8298-B9ED3141F3AD}"/>
                </a:ext>
              </a:extLst>
            </p:cNvPr>
            <p:cNvSpPr txBox="1"/>
            <p:nvPr/>
          </p:nvSpPr>
          <p:spPr>
            <a:xfrm>
              <a:off x="4155740" y="2030253"/>
              <a:ext cx="4539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7.4</a:t>
              </a:r>
              <a:endParaRPr kumimoji="1" lang="ja-JP" altLang="en-US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ABA5110-BF80-499C-B718-021B8E26A91E}"/>
              </a:ext>
            </a:extLst>
          </p:cNvPr>
          <p:cNvSpPr txBox="1"/>
          <p:nvPr/>
        </p:nvSpPr>
        <p:spPr>
          <a:xfrm>
            <a:off x="2134523" y="3794792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7CC8601A-EAF2-4AE3-9B05-7889B53CBF46}"/>
              </a:ext>
            </a:extLst>
          </p:cNvPr>
          <p:cNvGrpSpPr/>
          <p:nvPr/>
        </p:nvGrpSpPr>
        <p:grpSpPr>
          <a:xfrm>
            <a:off x="2623107" y="4012590"/>
            <a:ext cx="1770237" cy="2009328"/>
            <a:chOff x="4208380" y="6216001"/>
            <a:chExt cx="1770237" cy="2009328"/>
          </a:xfrm>
        </p:grpSpPr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E42A0DAF-DE25-4FF2-B557-EF6080F7C09F}"/>
                </a:ext>
              </a:extLst>
            </p:cNvPr>
            <p:cNvSpPr txBox="1"/>
            <p:nvPr/>
          </p:nvSpPr>
          <p:spPr>
            <a:xfrm>
              <a:off x="4606224" y="7540071"/>
              <a:ext cx="357216" cy="2224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CR</a:t>
              </a:r>
              <a:endParaRPr kumimoji="1"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45505330-8E80-4CAA-AF02-504DEA673F82}"/>
                </a:ext>
              </a:extLst>
            </p:cNvPr>
            <p:cNvSpPr txBox="1"/>
            <p:nvPr/>
          </p:nvSpPr>
          <p:spPr>
            <a:xfrm>
              <a:off x="5272838" y="7539269"/>
              <a:ext cx="558410" cy="2224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</a:t>
              </a:r>
              <a:r>
                <a:rPr kumimoji="1" lang="en-US" altLang="ja-JP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CR</a:t>
              </a:r>
              <a:endParaRPr kumimoji="1"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60128CB3-197A-45B9-8045-FC6AFCA83DA6}"/>
                </a:ext>
              </a:extLst>
            </p:cNvPr>
            <p:cNvSpPr txBox="1"/>
            <p:nvPr/>
          </p:nvSpPr>
          <p:spPr>
            <a:xfrm>
              <a:off x="4587059" y="7713064"/>
              <a:ext cx="540510" cy="20851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=18)</a:t>
              </a:r>
              <a:endPara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D861F1A7-098F-430A-9049-48EFC7128919}"/>
                </a:ext>
              </a:extLst>
            </p:cNvPr>
            <p:cNvSpPr txBox="1"/>
            <p:nvPr/>
          </p:nvSpPr>
          <p:spPr>
            <a:xfrm>
              <a:off x="5361751" y="7713064"/>
              <a:ext cx="540510" cy="20851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=16)</a:t>
              </a:r>
              <a:endPara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53" name="グラフ 52">
              <a:extLst>
                <a:ext uri="{FF2B5EF4-FFF2-40B4-BE49-F238E27FC236}">
                  <a16:creationId xmlns:a16="http://schemas.microsoft.com/office/drawing/2014/main" id="{24D5F8E6-C416-4106-86D6-40443DF812B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49920180"/>
                </p:ext>
              </p:extLst>
            </p:nvPr>
          </p:nvGraphicFramePr>
          <p:xfrm>
            <a:off x="4208380" y="6231186"/>
            <a:ext cx="1770237" cy="13647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DD7F631E-CB74-48E9-8C1F-AA1329560944}"/>
                </a:ext>
              </a:extLst>
            </p:cNvPr>
            <p:cNvSpPr txBox="1"/>
            <p:nvPr/>
          </p:nvSpPr>
          <p:spPr>
            <a:xfrm>
              <a:off x="4715872" y="7137944"/>
              <a:ext cx="163522" cy="2502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DC811DAF-EDA0-4525-BD4E-5A9C6C89FAE5}"/>
                </a:ext>
              </a:extLst>
            </p:cNvPr>
            <p:cNvSpPr txBox="1"/>
            <p:nvPr/>
          </p:nvSpPr>
          <p:spPr>
            <a:xfrm>
              <a:off x="4707133" y="6663336"/>
              <a:ext cx="163522" cy="2502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F8A36651-F789-4F71-B314-0B4166C369EA}"/>
                </a:ext>
              </a:extLst>
            </p:cNvPr>
            <p:cNvSpPr txBox="1"/>
            <p:nvPr/>
          </p:nvSpPr>
          <p:spPr>
            <a:xfrm>
              <a:off x="5466784" y="7259299"/>
              <a:ext cx="165222" cy="2502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ja-JP" alt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87283BA7-B7E9-43A4-B9E0-B44EBA833117}"/>
                </a:ext>
              </a:extLst>
            </p:cNvPr>
            <p:cNvSpPr txBox="1"/>
            <p:nvPr/>
          </p:nvSpPr>
          <p:spPr>
            <a:xfrm>
              <a:off x="5423995" y="6854001"/>
              <a:ext cx="377523" cy="2502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5" name="グループ化 64">
              <a:extLst>
                <a:ext uri="{FF2B5EF4-FFF2-40B4-BE49-F238E27FC236}">
                  <a16:creationId xmlns:a16="http://schemas.microsoft.com/office/drawing/2014/main" id="{4D30A08E-A5E6-4D95-9760-0561380ACF64}"/>
                </a:ext>
              </a:extLst>
            </p:cNvPr>
            <p:cNvGrpSpPr/>
            <p:nvPr/>
          </p:nvGrpSpPr>
          <p:grpSpPr>
            <a:xfrm>
              <a:off x="4674279" y="6316722"/>
              <a:ext cx="973367" cy="225800"/>
              <a:chOff x="4931228" y="2097308"/>
              <a:chExt cx="3178629" cy="1001482"/>
            </a:xfrm>
          </p:grpSpPr>
          <p:cxnSp>
            <p:nvCxnSpPr>
              <p:cNvPr id="72" name="直線コネクタ 71">
                <a:extLst>
                  <a:ext uri="{FF2B5EF4-FFF2-40B4-BE49-F238E27FC236}">
                    <a16:creationId xmlns:a16="http://schemas.microsoft.com/office/drawing/2014/main" id="{A8D51681-A03E-404E-A3AB-B7DE546067FC}"/>
                  </a:ext>
                </a:extLst>
              </p:cNvPr>
              <p:cNvCxnSpPr/>
              <p:nvPr/>
            </p:nvCxnSpPr>
            <p:spPr>
              <a:xfrm>
                <a:off x="4931228" y="2111825"/>
                <a:ext cx="0" cy="39188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線コネクタ 72">
                <a:extLst>
                  <a:ext uri="{FF2B5EF4-FFF2-40B4-BE49-F238E27FC236}">
                    <a16:creationId xmlns:a16="http://schemas.microsoft.com/office/drawing/2014/main" id="{DFD8C2B7-E2E4-417D-B0DF-E8D3A7155B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09857" y="2097308"/>
                <a:ext cx="0" cy="100148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線コネクタ 73">
                <a:extLst>
                  <a:ext uri="{FF2B5EF4-FFF2-40B4-BE49-F238E27FC236}">
                    <a16:creationId xmlns:a16="http://schemas.microsoft.com/office/drawing/2014/main" id="{F158B494-7B42-4042-BB6D-6749F85334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31228" y="2122711"/>
                <a:ext cx="317862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6CE3BCFF-C42A-4E2B-AA1B-4D3F4F3F4972}"/>
                </a:ext>
              </a:extLst>
            </p:cNvPr>
            <p:cNvSpPr txBox="1"/>
            <p:nvPr/>
          </p:nvSpPr>
          <p:spPr>
            <a:xfrm>
              <a:off x="4888866" y="6216001"/>
              <a:ext cx="650465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134</a:t>
              </a:r>
              <a:endPara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EC46D325-6C58-4303-8633-EA06658A290B}"/>
                </a:ext>
              </a:extLst>
            </p:cNvPr>
            <p:cNvSpPr/>
            <p:nvPr/>
          </p:nvSpPr>
          <p:spPr>
            <a:xfrm>
              <a:off x="5051295" y="8058105"/>
              <a:ext cx="104611" cy="107844"/>
            </a:xfrm>
            <a:prstGeom prst="rect">
              <a:avLst/>
            </a:prstGeom>
            <a:pattFill prst="pct9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D6CC11C8-5852-4956-90CE-54CE4BA0EBB9}"/>
                </a:ext>
              </a:extLst>
            </p:cNvPr>
            <p:cNvSpPr/>
            <p:nvPr/>
          </p:nvSpPr>
          <p:spPr>
            <a:xfrm>
              <a:off x="5434720" y="8058105"/>
              <a:ext cx="104611" cy="107844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F3B83D24-2561-4CFC-BE2F-BF8C5A01F99C}"/>
                </a:ext>
              </a:extLst>
            </p:cNvPr>
            <p:cNvSpPr txBox="1"/>
            <p:nvPr/>
          </p:nvSpPr>
          <p:spPr>
            <a:xfrm>
              <a:off x="4583455" y="7994497"/>
              <a:ext cx="4988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ea typeface="Meiryo UI" panose="020B0604030504040204" pitchFamily="50" charset="-128"/>
                  <a:cs typeface="Times New Roman" panose="02020603050405020304" pitchFamily="18" charset="0"/>
                </a:rPr>
                <a:t>PD-L1</a:t>
              </a:r>
              <a:endParaRPr kumimoji="1" lang="ja-JP" altLang="en-US" sz="9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D82B3070-F7F4-42C8-9501-3E2273D966EC}"/>
                </a:ext>
              </a:extLst>
            </p:cNvPr>
            <p:cNvSpPr txBox="1"/>
            <p:nvPr/>
          </p:nvSpPr>
          <p:spPr>
            <a:xfrm>
              <a:off x="5134847" y="7994497"/>
              <a:ext cx="3273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B2940FCE-4CF2-44F5-8940-FD2C8DB39FC9}"/>
                </a:ext>
              </a:extLst>
            </p:cNvPr>
            <p:cNvSpPr txBox="1"/>
            <p:nvPr/>
          </p:nvSpPr>
          <p:spPr>
            <a:xfrm>
              <a:off x="5509681" y="7994497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EA82C18-EA86-4E93-B334-EA1C9931C4A0}"/>
              </a:ext>
            </a:extLst>
          </p:cNvPr>
          <p:cNvSpPr txBox="1"/>
          <p:nvPr/>
        </p:nvSpPr>
        <p:spPr>
          <a:xfrm rot="16200000">
            <a:off x="1668274" y="4688447"/>
            <a:ext cx="17091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D-L1 expression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2358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84</TotalTime>
  <Words>77</Words>
  <Application>Microsoft Office PowerPoint</Application>
  <PresentationFormat>画面に合わせる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二村学</dc:creator>
  <cp:lastModifiedBy>二村　学</cp:lastModifiedBy>
  <cp:revision>96</cp:revision>
  <dcterms:created xsi:type="dcterms:W3CDTF">2015-12-20T13:27:18Z</dcterms:created>
  <dcterms:modified xsi:type="dcterms:W3CDTF">2022-08-19T14:51:46Z</dcterms:modified>
</cp:coreProperties>
</file>